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B458C-88BA-4B15-848A-00691B8FF1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1FBD1-F5C5-416A-BF80-0C7AB6B9AA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18094-0AAC-4FAF-92C1-9B1E03A7AE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69905-CB0F-453A-AA1F-2B2B3E2CDC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F814E-9A73-4817-AA7E-C90BA24C99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CDB43-EC4D-45E9-BC62-21411DE94C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B8AB1-906D-4E65-9ECE-DB44BD5F89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0EED2-CA13-4411-83BC-1610FA6DD9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E8EC2-A100-42B6-B3D7-2FD0D74AD3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A3BE8-34FA-4214-89DD-89CF0AC993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6BCD5-7F36-46CA-955A-AE3EE81959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06A28-6A64-4171-AE77-FE369FAE97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nn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56BBA20-B361-42D4-802E-E5CE14DE7148}" type="datetime">
              <a:rPr b="0" lang="nn-NO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nn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BF49A84-2C35-4BC7-A535-80F0BADF8DB3}" type="slidenum">
              <a:rPr b="0" lang="nn-NO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14400" y="1447920"/>
          <a:ext cx="4495680" cy="1971720"/>
        </p:xfrm>
        <a:graphic>
          <a:graphicData uri="http://schemas.openxmlformats.org/drawingml/2006/table">
            <a:tbl>
              <a:tblPr/>
              <a:tblGrid>
                <a:gridCol w="2438280"/>
                <a:gridCol w="2057400"/>
              </a:tblGrid>
              <a:tr h="3650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 – airwa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Ok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 – breathing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/m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 – circul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Heart rate 100/min –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 – disabilit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wake (GCS 13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492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 – exposur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ruised pelv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Fractured underar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914400" y="5664240"/>
          <a:ext cx="4495680" cy="2095560"/>
        </p:xfrm>
        <a:graphic>
          <a:graphicData uri="http://schemas.openxmlformats.org/drawingml/2006/table">
            <a:tbl>
              <a:tblPr/>
              <a:tblGrid>
                <a:gridCol w="2286000"/>
                <a:gridCol w="2209680"/>
              </a:tblGrid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 – Airway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4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Ok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B – Breathing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22/m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</a:tr>
              <a:tr h="490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 – Circul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Heart rate 130/min – pale sk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</a:tr>
              <a:tr h="490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D – Disabilit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Gradually confused –(GCS 1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 – Exposur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400" spc="-1" strike="noStrike">
                          <a:solidFill>
                            <a:srgbClr val="ffffff"/>
                          </a:solidFill>
                          <a:latin typeface="Arial"/>
                          <a:ea typeface="Calibri"/>
                        </a:rPr>
                        <a:t>Freez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43" name="Tittel 1"/>
          <p:cNvSpPr/>
          <p:nvPr/>
        </p:nvSpPr>
        <p:spPr>
          <a:xfrm>
            <a:off x="343080" y="3657600"/>
            <a:ext cx="617220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kstSylinder 6"/>
          <p:cNvSpPr/>
          <p:nvPr/>
        </p:nvSpPr>
        <p:spPr>
          <a:xfrm>
            <a:off x="914400" y="847800"/>
            <a:ext cx="5105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Patient number</a:t>
            </a:r>
            <a:r>
              <a:rPr b="1" lang="en-GB" sz="1600" spc="-1" strike="noStrike">
                <a:solidFill>
                  <a:srgbClr val="800000"/>
                </a:solidFill>
                <a:latin typeface="Arial"/>
                <a:ea typeface="Arial"/>
              </a:rPr>
              <a:t> 10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(Inside wreck)</a:t>
            </a:r>
            <a:r>
              <a:rPr b="1" lang="en-GB" sz="1600" spc="-1" strike="noStrike">
                <a:solidFill>
                  <a:srgbClr val="800000"/>
                </a:solidFill>
                <a:latin typeface="Arial"/>
                <a:ea typeface="Arial"/>
              </a:rPr>
              <a:t> </a:t>
            </a:r>
            <a:br>
              <a:rPr sz="1600"/>
            </a:b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Vital signs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/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Primary surve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kstSylinder 7"/>
          <p:cNvSpPr/>
          <p:nvPr/>
        </p:nvSpPr>
        <p:spPr>
          <a:xfrm>
            <a:off x="944280" y="5018040"/>
            <a:ext cx="4244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Patient number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GB" sz="1600" spc="-1" strike="noStrike">
                <a:solidFill>
                  <a:srgbClr val="800000"/>
                </a:solidFill>
                <a:latin typeface="Arial"/>
                <a:ea typeface="Arial"/>
              </a:rPr>
              <a:t>10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(Casualty clearing station)</a:t>
            </a:r>
            <a:br>
              <a:rPr sz="1600"/>
            </a:b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Vital signs / Primary surve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uppe 8"/>
          <p:cNvGrpSpPr/>
          <p:nvPr/>
        </p:nvGrpSpPr>
        <p:grpSpPr>
          <a:xfrm>
            <a:off x="914400" y="3844800"/>
            <a:ext cx="4495680" cy="378000"/>
            <a:chOff x="914400" y="3844800"/>
            <a:chExt cx="4495680" cy="378000"/>
          </a:xfrm>
        </p:grpSpPr>
        <p:pic>
          <p:nvPicPr>
            <p:cNvPr id="47" name="Picture 9" descr="TAS logo"/>
            <p:cNvPicPr/>
            <p:nvPr/>
          </p:nvPicPr>
          <p:blipFill>
            <a:blip r:embed="rId1"/>
            <a:stretch/>
          </p:blipFill>
          <p:spPr>
            <a:xfrm>
              <a:off x="3809880" y="3844800"/>
              <a:ext cx="1600200" cy="37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kstSylinder 10"/>
            <p:cNvSpPr/>
            <p:nvPr/>
          </p:nvSpPr>
          <p:spPr>
            <a:xfrm>
              <a:off x="914400" y="3844800"/>
              <a:ext cx="129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S 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Gruppe 11"/>
          <p:cNvGrpSpPr/>
          <p:nvPr/>
        </p:nvGrpSpPr>
        <p:grpSpPr>
          <a:xfrm>
            <a:off x="914400" y="8061480"/>
            <a:ext cx="4495680" cy="377640"/>
            <a:chOff x="914400" y="8061480"/>
            <a:chExt cx="4495680" cy="377640"/>
          </a:xfrm>
        </p:grpSpPr>
        <p:pic>
          <p:nvPicPr>
            <p:cNvPr id="50" name="Picture 9" descr="TAS logo"/>
            <p:cNvPicPr/>
            <p:nvPr/>
          </p:nvPicPr>
          <p:blipFill>
            <a:blip r:embed="rId2"/>
            <a:stretch/>
          </p:blipFill>
          <p:spPr>
            <a:xfrm>
              <a:off x="3809880" y="8061480"/>
              <a:ext cx="1600200" cy="377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kstSylinder 13"/>
            <p:cNvSpPr/>
            <p:nvPr/>
          </p:nvSpPr>
          <p:spPr>
            <a:xfrm>
              <a:off x="914400" y="8061480"/>
              <a:ext cx="129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nn-NO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S 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30T13:17:07Z</dcterms:created>
  <dc:creator>Jan Einar Andersen</dc:creator>
  <dc:description/>
  <dc:language>en-US</dc:language>
  <cp:lastModifiedBy>Rehn Marius</cp:lastModifiedBy>
  <cp:lastPrinted>2009-03-28T15:31:33Z</cp:lastPrinted>
  <dcterms:modified xsi:type="dcterms:W3CDTF">2010-05-30T13:29:41Z</dcterms:modified>
  <cp:revision>39</cp:revision>
  <dc:subject/>
  <dc:title>Hvit  - fase Alfa  (øvelsens inngangsverdier)      1 Vitale funksjoner Primær US og funn        </dc:title>
</cp:coreProperties>
</file>